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827" autoAdjust="0"/>
    <p:restoredTop sz="94660"/>
  </p:normalViewPr>
  <p:slideViewPr>
    <p:cSldViewPr snapToGrid="0">
      <p:cViewPr varScale="1">
        <p:scale>
          <a:sx n="73" d="100"/>
          <a:sy n="73" d="100"/>
        </p:scale>
        <p:origin x="181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7204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4325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4033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878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1674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2647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9173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977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0201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2623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810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9E9205-162A-4D48-97ED-246D98D19020}" type="datetimeFigureOut">
              <a:rPr lang="en-GB" smtClean="0"/>
              <a:t>22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8A538-1D3B-4AD2-9B7C-72D50319F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118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694629" y="396444"/>
            <a:ext cx="5760000" cy="234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044" y="7223"/>
            <a:ext cx="2196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0" y="5347112"/>
            <a:ext cx="9144000" cy="15124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cytochemical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etection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xidativ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NA damage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low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liferative DPSC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b-populations,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2 (2-10PDs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C3 (2-10PDs),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uring extended culture with or without exogenous H</a:t>
            </a:r>
            <a:r>
              <a:rPr lang="en-GB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50-20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. 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TC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reen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iv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luorescence microscopy images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8-OHdG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rke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tectio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rrowe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oechs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clear stain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lue, v-viii).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=3, scale ba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×200 magnificatio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 smtClean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3983FF8-E430-4E2B-AFE7-A3B7F3008A84}"/>
              </a:ext>
            </a:extLst>
          </p:cNvPr>
          <p:cNvSpPr txBox="1"/>
          <p:nvPr/>
        </p:nvSpPr>
        <p:spPr>
          <a:xfrm>
            <a:off x="1694636" y="450386"/>
            <a:ext cx="3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694381" y="3018646"/>
            <a:ext cx="5760000" cy="2340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C3983FF8-E430-4E2B-AFE7-A3B7F3008A84}"/>
              </a:ext>
            </a:extLst>
          </p:cNvPr>
          <p:cNvSpPr txBox="1"/>
          <p:nvPr/>
        </p:nvSpPr>
        <p:spPr>
          <a:xfrm>
            <a:off x="1692243" y="3084728"/>
            <a:ext cx="3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8159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95</TotalTime>
  <Words>78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ardiff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Paper</dc:title>
  <dc:creator>insrv</dc:creator>
  <cp:lastModifiedBy>Ryan Moseley</cp:lastModifiedBy>
  <cp:revision>307</cp:revision>
  <cp:lastPrinted>2018-10-18T13:09:14Z</cp:lastPrinted>
  <dcterms:created xsi:type="dcterms:W3CDTF">2017-05-24T09:17:58Z</dcterms:created>
  <dcterms:modified xsi:type="dcterms:W3CDTF">2020-10-22T12:08:01Z</dcterms:modified>
</cp:coreProperties>
</file>